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  <p:ext uri="{2D200454-40CA-4A62-9FC3-DE9A4176ACB9}">
      <p15:notes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eman, Zachary" initials="FZ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FF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13" autoAdjust="0"/>
    <p:restoredTop sz="69903" autoAdjust="0"/>
  </p:normalViewPr>
  <p:slideViewPr>
    <p:cSldViewPr snapToGrid="0">
      <p:cViewPr>
        <p:scale>
          <a:sx n="160" d="100"/>
          <a:sy n="160" d="100"/>
        </p:scale>
        <p:origin x="-252" y="34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3" d="100"/>
          <a:sy n="73" d="100"/>
        </p:scale>
        <p:origin x="22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6740" y="1"/>
            <a:ext cx="3041968" cy="467451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DBD3558C-0035-48B5-AB58-788A86F55A4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6740" y="8838476"/>
            <a:ext cx="3041968" cy="467450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777CC2A-ED66-41CA-8D7C-0DED167903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290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4" y="1"/>
            <a:ext cx="3041968" cy="466912"/>
          </a:xfrm>
          <a:prstGeom prst="rect">
            <a:avLst/>
          </a:prstGeom>
        </p:spPr>
        <p:txBody>
          <a:bodyPr vert="horz" lIns="93279" tIns="46641" rIns="93279" bIns="46641" rtlCol="0"/>
          <a:lstStyle>
            <a:lvl1pPr algn="r">
              <a:defRPr sz="1200"/>
            </a:lvl1pPr>
          </a:lstStyle>
          <a:p>
            <a:fld id="{58E5CAB3-8DA8-4612-9FB4-C043D70D76FF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6050" y="1163638"/>
            <a:ext cx="4187825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1" rIns="93279" bIns="4664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7"/>
            <a:ext cx="5615940" cy="3664209"/>
          </a:xfrm>
          <a:prstGeom prst="rect">
            <a:avLst/>
          </a:prstGeom>
        </p:spPr>
        <p:txBody>
          <a:bodyPr vert="horz" lIns="93279" tIns="46641" rIns="93279" bIns="46641" rtlCol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4" y="8839015"/>
            <a:ext cx="3041968" cy="466911"/>
          </a:xfrm>
          <a:prstGeom prst="rect">
            <a:avLst/>
          </a:prstGeom>
        </p:spPr>
        <p:txBody>
          <a:bodyPr vert="horz" lIns="93279" tIns="46641" rIns="93279" bIns="46641" rtlCol="0" anchor="b"/>
          <a:lstStyle>
            <a:lvl1pPr algn="r">
              <a:defRPr sz="1200"/>
            </a:lvl1pPr>
          </a:lstStyle>
          <a:p>
            <a:fld id="{B9F49ED3-0D8E-400C-AB96-46AED9631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864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6050" y="1163638"/>
            <a:ext cx="4187825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2794">
              <a:defRPr/>
            </a:pPr>
            <a:r>
              <a:rPr lang="en-US" dirty="0"/>
              <a:t>S2A. Representative</a:t>
            </a:r>
            <a:r>
              <a:rPr lang="en-US" baseline="0" dirty="0"/>
              <a:t> FACS histograms showing changes in PD-L1 expression in MC38OVA cells treated with JQ1 and/or IFN</a:t>
            </a:r>
            <a:r>
              <a:rPr lang="el-GR" baseline="0" dirty="0"/>
              <a:t>γ</a:t>
            </a:r>
            <a:r>
              <a:rPr lang="en-US" baseline="0" dirty="0"/>
              <a:t>. </a:t>
            </a:r>
          </a:p>
          <a:p>
            <a:pPr defTabSz="932794">
              <a:defRPr/>
            </a:pPr>
            <a:r>
              <a:rPr lang="en-US" baseline="0" dirty="0"/>
              <a:t>S2B.</a:t>
            </a:r>
            <a:r>
              <a:rPr lang="en-US" dirty="0"/>
              <a:t> </a:t>
            </a:r>
            <a:r>
              <a:rPr lang="en-US" baseline="0" dirty="0"/>
              <a:t>Summary of changes in PD-L1 expression by MFI (normalized to DMSO control) in MC38OVA cells treated with JQ1 and/or </a:t>
            </a:r>
            <a:r>
              <a:rPr lang="en-US" baseline="0" dirty="0" err="1"/>
              <a:t>IFNy</a:t>
            </a:r>
            <a:r>
              <a:rPr lang="en-US" baseline="0" dirty="0"/>
              <a:t>. </a:t>
            </a:r>
          </a:p>
          <a:p>
            <a:pPr defTabSz="932794">
              <a:defRPr/>
            </a:pPr>
            <a:r>
              <a:rPr lang="en-US" dirty="0"/>
              <a:t>s2C. Representative</a:t>
            </a:r>
            <a:r>
              <a:rPr lang="en-US" baseline="0" dirty="0"/>
              <a:t> FACS histograms showing changes in H2K</a:t>
            </a:r>
            <a:r>
              <a:rPr lang="en-US" baseline="30000" dirty="0"/>
              <a:t>b</a:t>
            </a:r>
            <a:r>
              <a:rPr lang="en-US" baseline="0" dirty="0"/>
              <a:t>D</a:t>
            </a:r>
            <a:r>
              <a:rPr lang="en-US" baseline="30000" dirty="0"/>
              <a:t>b</a:t>
            </a:r>
            <a:r>
              <a:rPr lang="en-US" baseline="0" dirty="0"/>
              <a:t> expression in MC38OVA cells treated with JQ1 and/or IFN</a:t>
            </a:r>
            <a:r>
              <a:rPr lang="el-GR" baseline="0" dirty="0"/>
              <a:t>γ</a:t>
            </a:r>
            <a:r>
              <a:rPr lang="en-US" baseline="0" dirty="0"/>
              <a:t>. </a:t>
            </a:r>
          </a:p>
          <a:p>
            <a:pPr defTabSz="932794">
              <a:defRPr/>
            </a:pPr>
            <a:r>
              <a:rPr lang="en-US" baseline="0" dirty="0"/>
              <a:t>S2D.</a:t>
            </a:r>
            <a:r>
              <a:rPr lang="en-US" dirty="0"/>
              <a:t> </a:t>
            </a:r>
            <a:r>
              <a:rPr lang="en-US" baseline="0" dirty="0"/>
              <a:t>Summary of changes in H2K</a:t>
            </a:r>
            <a:r>
              <a:rPr lang="en-US" baseline="30000" dirty="0"/>
              <a:t>b</a:t>
            </a:r>
            <a:r>
              <a:rPr lang="en-US" baseline="0" dirty="0"/>
              <a:t>D</a:t>
            </a:r>
            <a:r>
              <a:rPr lang="en-US" baseline="30000" dirty="0"/>
              <a:t>b</a:t>
            </a:r>
            <a:r>
              <a:rPr lang="en-US" baseline="0" dirty="0"/>
              <a:t> expression by MFI (normalized to DMSO control)  in MC38OVA cells treated with JQ1 and/or IFN</a:t>
            </a:r>
            <a:r>
              <a:rPr lang="el-GR" baseline="0" dirty="0"/>
              <a:t>γ</a:t>
            </a:r>
            <a:r>
              <a:rPr lang="en-US" baseline="0" dirty="0"/>
              <a:t>. </a:t>
            </a:r>
          </a:p>
          <a:p>
            <a:pPr defTabSz="932794">
              <a:defRPr/>
            </a:pPr>
            <a:endParaRPr lang="en-US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49ED3-0D8E-400C-AB96-46AED96312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475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56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114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970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95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01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29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5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350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31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102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560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E5665-A513-49FD-94A7-3D6FF2F4526C}" type="datetimeFigureOut">
              <a:rPr lang="en-US" smtClean="0"/>
              <a:t>10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B6D27-D3A9-437C-8429-3F7D9F5BBF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89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60" t="51007" r="52983" b="5161"/>
          <a:stretch/>
        </p:blipFill>
        <p:spPr>
          <a:xfrm>
            <a:off x="252073" y="3469554"/>
            <a:ext cx="2358612" cy="2193221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5038" b="52299"/>
          <a:stretch/>
        </p:blipFill>
        <p:spPr>
          <a:xfrm>
            <a:off x="-120941" y="729625"/>
            <a:ext cx="2630524" cy="2347871"/>
          </a:xfrm>
          <a:prstGeom prst="rect">
            <a:avLst/>
          </a:prstGeom>
        </p:spPr>
      </p:pic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6663079"/>
              </p:ext>
            </p:extLst>
          </p:nvPr>
        </p:nvGraphicFramePr>
        <p:xfrm>
          <a:off x="4738852" y="2664669"/>
          <a:ext cx="2897597" cy="3566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10" name="Prism 7" r:id="rId5" imgW="3719842" imgH="4578638" progId="Prism7.Document">
                  <p:embed/>
                </p:oleObj>
              </mc:Choice>
              <mc:Fallback>
                <p:oleObj name="Prism 7" r:id="rId5" imgW="3719842" imgH="457863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38852" y="2664669"/>
                        <a:ext cx="2897597" cy="3566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Rectangle 79"/>
          <p:cNvSpPr/>
          <p:nvPr/>
        </p:nvSpPr>
        <p:spPr>
          <a:xfrm>
            <a:off x="5213291" y="5141696"/>
            <a:ext cx="2322950" cy="7777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8170766"/>
              </p:ext>
            </p:extLst>
          </p:nvPr>
        </p:nvGraphicFramePr>
        <p:xfrm>
          <a:off x="4852304" y="362768"/>
          <a:ext cx="2866216" cy="3406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11" name="Prism 7" r:id="rId7" imgW="3576508" imgH="4250898" progId="Prism7.Document">
                  <p:embed/>
                </p:oleObj>
              </mc:Choice>
              <mc:Fallback>
                <p:oleObj name="Prism 7" r:id="rId7" imgW="3576508" imgH="425089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852304" y="362768"/>
                        <a:ext cx="2866216" cy="34068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Rectangle 42"/>
          <p:cNvSpPr/>
          <p:nvPr/>
        </p:nvSpPr>
        <p:spPr>
          <a:xfrm>
            <a:off x="5200899" y="2673657"/>
            <a:ext cx="2322950" cy="7777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64" name="Group 63"/>
          <p:cNvGrpSpPr/>
          <p:nvPr/>
        </p:nvGrpSpPr>
        <p:grpSpPr>
          <a:xfrm>
            <a:off x="5584599" y="2668774"/>
            <a:ext cx="2276598" cy="538074"/>
            <a:chOff x="3885781" y="1939809"/>
            <a:chExt cx="831003" cy="823166"/>
          </a:xfrm>
          <a:solidFill>
            <a:schemeClr val="bg1"/>
          </a:solidFill>
        </p:grpSpPr>
        <p:sp>
          <p:nvSpPr>
            <p:cNvPr id="65" name="TextBox 64"/>
            <p:cNvSpPr txBox="1"/>
            <p:nvPr/>
          </p:nvSpPr>
          <p:spPr>
            <a:xfrm>
              <a:off x="3886810" y="1939809"/>
              <a:ext cx="829974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-         -         +         +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885781" y="2303898"/>
              <a:ext cx="725751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-         +         -         +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51210" y="1555986"/>
            <a:ext cx="664604" cy="1360728"/>
            <a:chOff x="1661547" y="1015730"/>
            <a:chExt cx="886138" cy="1814304"/>
          </a:xfrm>
        </p:grpSpPr>
        <p:sp>
          <p:nvSpPr>
            <p:cNvPr id="20" name="TextBox 19"/>
            <p:cNvSpPr txBox="1"/>
            <p:nvPr/>
          </p:nvSpPr>
          <p:spPr>
            <a:xfrm>
              <a:off x="1671254" y="1015730"/>
              <a:ext cx="876431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2114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61547" y="1492014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863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65335" y="2011116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0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70626" y="2491479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50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02353" y="4106930"/>
            <a:ext cx="668678" cy="1344605"/>
            <a:chOff x="1638982" y="4831792"/>
            <a:chExt cx="891570" cy="1792807"/>
          </a:xfrm>
        </p:grpSpPr>
        <p:sp>
          <p:nvSpPr>
            <p:cNvPr id="32" name="TextBox 31"/>
            <p:cNvSpPr txBox="1"/>
            <p:nvPr/>
          </p:nvSpPr>
          <p:spPr>
            <a:xfrm>
              <a:off x="1654122" y="4831792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43021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654122" y="5329431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58010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638982" y="5848100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7428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639018" y="6286044"/>
              <a:ext cx="87643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1119</a:t>
              </a: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-22700" y="858256"/>
            <a:ext cx="54384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-50721" y="3197820"/>
            <a:ext cx="62067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21143" y="3064725"/>
            <a:ext cx="186580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D-L1 expression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PE fluorescence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398785" y="892568"/>
            <a:ext cx="65087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385928" y="3236895"/>
            <a:ext cx="59022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80891" y="2898221"/>
            <a:ext cx="207220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grpSp>
        <p:nvGrpSpPr>
          <p:cNvPr id="71" name="Group 70"/>
          <p:cNvGrpSpPr/>
          <p:nvPr/>
        </p:nvGrpSpPr>
        <p:grpSpPr>
          <a:xfrm>
            <a:off x="2365748" y="1511050"/>
            <a:ext cx="1345787" cy="1376047"/>
            <a:chOff x="3881537" y="1952916"/>
            <a:chExt cx="985947" cy="1834730"/>
          </a:xfrm>
        </p:grpSpPr>
        <p:sp>
          <p:nvSpPr>
            <p:cNvPr id="72" name="TextBox 71"/>
            <p:cNvSpPr txBox="1"/>
            <p:nvPr/>
          </p:nvSpPr>
          <p:spPr>
            <a:xfrm>
              <a:off x="3882643" y="1952916"/>
              <a:ext cx="82997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20 ng/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L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881537" y="2411861"/>
              <a:ext cx="985947" cy="55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JQ1 + 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</a:p>
            <a:p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886810" y="2924158"/>
              <a:ext cx="82984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JQ1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897070" y="3449091"/>
              <a:ext cx="82984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</p:grpSp>
      <p:sp>
        <p:nvSpPr>
          <p:cNvPr id="83" name="TextBox 82"/>
          <p:cNvSpPr txBox="1"/>
          <p:nvPr/>
        </p:nvSpPr>
        <p:spPr>
          <a:xfrm rot="16200000">
            <a:off x="-403981" y="1792106"/>
            <a:ext cx="1361996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lative cell number</a:t>
            </a:r>
          </a:p>
        </p:txBody>
      </p:sp>
      <p:sp>
        <p:nvSpPr>
          <p:cNvPr id="84" name="TextBox 83"/>
          <p:cNvSpPr txBox="1"/>
          <p:nvPr/>
        </p:nvSpPr>
        <p:spPr>
          <a:xfrm rot="16200000">
            <a:off x="-396481" y="4299923"/>
            <a:ext cx="1361996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lative cell number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34018" y="5485502"/>
            <a:ext cx="207220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    10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477171" y="5659569"/>
            <a:ext cx="186580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2K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APC fluorescence)</a:t>
            </a:r>
          </a:p>
        </p:txBody>
      </p:sp>
      <p:grpSp>
        <p:nvGrpSpPr>
          <p:cNvPr id="88" name="Group 87"/>
          <p:cNvGrpSpPr/>
          <p:nvPr/>
        </p:nvGrpSpPr>
        <p:grpSpPr>
          <a:xfrm>
            <a:off x="2342978" y="3969959"/>
            <a:ext cx="1345787" cy="1479407"/>
            <a:chOff x="3876336" y="1952916"/>
            <a:chExt cx="985947" cy="1972543"/>
          </a:xfrm>
        </p:grpSpPr>
        <p:sp>
          <p:nvSpPr>
            <p:cNvPr id="90" name="TextBox 89"/>
            <p:cNvSpPr txBox="1"/>
            <p:nvPr/>
          </p:nvSpPr>
          <p:spPr>
            <a:xfrm>
              <a:off x="3882643" y="1952916"/>
              <a:ext cx="82997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20 ng/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L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876336" y="2486245"/>
              <a:ext cx="985947" cy="55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JQ1 + 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</a:p>
            <a:p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884094" y="3047195"/>
              <a:ext cx="82984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uM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 JQ1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884094" y="3586904"/>
              <a:ext cx="82984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</p:grpSp>
      <p:grpSp>
        <p:nvGrpSpPr>
          <p:cNvPr id="94" name="Group 93"/>
          <p:cNvGrpSpPr/>
          <p:nvPr/>
        </p:nvGrpSpPr>
        <p:grpSpPr>
          <a:xfrm>
            <a:off x="7588802" y="2654953"/>
            <a:ext cx="653760" cy="528351"/>
            <a:chOff x="3886812" y="2010106"/>
            <a:chExt cx="597968" cy="822399"/>
          </a:xfrm>
          <a:solidFill>
            <a:schemeClr val="bg1"/>
          </a:solidFill>
        </p:grpSpPr>
        <p:sp>
          <p:nvSpPr>
            <p:cNvPr id="95" name="TextBox 94"/>
            <p:cNvSpPr txBox="1"/>
            <p:nvPr/>
          </p:nvSpPr>
          <p:spPr>
            <a:xfrm>
              <a:off x="3886812" y="2010106"/>
              <a:ext cx="597968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886812" y="2437275"/>
              <a:ext cx="597967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JQ1</a:t>
              </a:r>
            </a:p>
          </p:txBody>
        </p:sp>
      </p:grpSp>
      <p:cxnSp>
        <p:nvCxnSpPr>
          <p:cNvPr id="97" name="Straight Connector 96"/>
          <p:cNvCxnSpPr/>
          <p:nvPr/>
        </p:nvCxnSpPr>
        <p:spPr>
          <a:xfrm>
            <a:off x="8137358" y="2740076"/>
            <a:ext cx="0" cy="34737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 rot="5400000">
            <a:off x="7849190" y="2834619"/>
            <a:ext cx="753349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MC38-OVA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476088" y="960772"/>
            <a:ext cx="753349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MC38-OVA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427848" y="3488698"/>
            <a:ext cx="753349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MC38-OVA</a:t>
            </a:r>
          </a:p>
        </p:txBody>
      </p:sp>
      <p:grpSp>
        <p:nvGrpSpPr>
          <p:cNvPr id="77" name="Group 76"/>
          <p:cNvGrpSpPr/>
          <p:nvPr/>
        </p:nvGrpSpPr>
        <p:grpSpPr>
          <a:xfrm>
            <a:off x="5540927" y="5153389"/>
            <a:ext cx="2276598" cy="538074"/>
            <a:chOff x="3885781" y="1939809"/>
            <a:chExt cx="831003" cy="823166"/>
          </a:xfrm>
          <a:solidFill>
            <a:schemeClr val="bg1"/>
          </a:solidFill>
        </p:grpSpPr>
        <p:sp>
          <p:nvSpPr>
            <p:cNvPr id="78" name="TextBox 77"/>
            <p:cNvSpPr txBox="1"/>
            <p:nvPr/>
          </p:nvSpPr>
          <p:spPr>
            <a:xfrm>
              <a:off x="3886810" y="1939809"/>
              <a:ext cx="829974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-         -         +         +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885781" y="2303898"/>
              <a:ext cx="725751" cy="4590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-         +         -         +</a:t>
              </a:r>
            </a:p>
          </p:txBody>
        </p:sp>
      </p:grpSp>
      <p:grpSp>
        <p:nvGrpSpPr>
          <p:cNvPr id="107" name="Group 106"/>
          <p:cNvGrpSpPr/>
          <p:nvPr/>
        </p:nvGrpSpPr>
        <p:grpSpPr>
          <a:xfrm>
            <a:off x="7588802" y="5112904"/>
            <a:ext cx="653760" cy="528351"/>
            <a:chOff x="3886812" y="2010106"/>
            <a:chExt cx="597968" cy="822399"/>
          </a:xfrm>
          <a:solidFill>
            <a:schemeClr val="bg1"/>
          </a:solidFill>
        </p:grpSpPr>
        <p:sp>
          <p:nvSpPr>
            <p:cNvPr id="108" name="TextBox 107"/>
            <p:cNvSpPr txBox="1"/>
            <p:nvPr/>
          </p:nvSpPr>
          <p:spPr>
            <a:xfrm>
              <a:off x="3886812" y="2010106"/>
              <a:ext cx="597968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886812" y="2437275"/>
              <a:ext cx="597967" cy="39523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JQ1</a:t>
              </a:r>
            </a:p>
          </p:txBody>
        </p:sp>
      </p:grpSp>
      <p:cxnSp>
        <p:nvCxnSpPr>
          <p:cNvPr id="112" name="Straight Connector 111"/>
          <p:cNvCxnSpPr/>
          <p:nvPr/>
        </p:nvCxnSpPr>
        <p:spPr>
          <a:xfrm>
            <a:off x="8137358" y="5198027"/>
            <a:ext cx="0" cy="34737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 rot="5400000">
            <a:off x="7849190" y="5292570"/>
            <a:ext cx="753349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MC38-OV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-25478" y="6573731"/>
            <a:ext cx="397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o et. al. </a:t>
            </a:r>
          </a:p>
        </p:txBody>
      </p:sp>
      <p:sp>
        <p:nvSpPr>
          <p:cNvPr id="2" name="Rectangle 1"/>
          <p:cNvSpPr/>
          <p:nvPr/>
        </p:nvSpPr>
        <p:spPr>
          <a:xfrm>
            <a:off x="5684850" y="2040157"/>
            <a:ext cx="529954" cy="1691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728488" y="892568"/>
            <a:ext cx="743874" cy="2074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6607640" y="1163302"/>
            <a:ext cx="662445" cy="1124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613909" y="910148"/>
            <a:ext cx="973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**** p&lt;0.0001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6417083" y="1090866"/>
            <a:ext cx="973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**** p&lt;0.000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762594" y="2001626"/>
            <a:ext cx="374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76" name="Rectangle 75"/>
          <p:cNvSpPr/>
          <p:nvPr/>
        </p:nvSpPr>
        <p:spPr>
          <a:xfrm>
            <a:off x="5684850" y="3451368"/>
            <a:ext cx="662445" cy="1124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574535" y="3370117"/>
            <a:ext cx="973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*** p=0.0006</a:t>
            </a:r>
          </a:p>
        </p:txBody>
      </p:sp>
      <p:sp>
        <p:nvSpPr>
          <p:cNvPr id="82" name="Rectangle 81"/>
          <p:cNvSpPr/>
          <p:nvPr/>
        </p:nvSpPr>
        <p:spPr>
          <a:xfrm>
            <a:off x="6528553" y="3558153"/>
            <a:ext cx="743874" cy="2074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413974" y="3575733"/>
            <a:ext cx="9730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*** p=0.0001</a:t>
            </a:r>
          </a:p>
        </p:txBody>
      </p:sp>
      <p:sp>
        <p:nvSpPr>
          <p:cNvPr id="89" name="Rectangle 88"/>
          <p:cNvSpPr/>
          <p:nvPr/>
        </p:nvSpPr>
        <p:spPr>
          <a:xfrm>
            <a:off x="5674737" y="3862078"/>
            <a:ext cx="743874" cy="2074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631717" y="3879658"/>
            <a:ext cx="3935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" name="Rectangle 2"/>
          <p:cNvSpPr/>
          <p:nvPr/>
        </p:nvSpPr>
        <p:spPr>
          <a:xfrm>
            <a:off x="5213291" y="269823"/>
            <a:ext cx="3122219" cy="5884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477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15</TotalTime>
  <Words>206</Words>
  <Application>Microsoft Office PowerPoint</Application>
  <PresentationFormat>On-screen Show (4:3)</PresentationFormat>
  <Paragraphs>52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7</vt:lpstr>
      <vt:lpstr>PowerPoint Presentation</vt:lpstr>
    </vt:vector>
  </TitlesOfParts>
  <Company>Columbia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Figures</dc:title>
  <dc:creator>Mao, Wendy</dc:creator>
  <cp:lastModifiedBy>USER</cp:lastModifiedBy>
  <cp:revision>253</cp:revision>
  <cp:lastPrinted>2019-02-04T21:11:13Z</cp:lastPrinted>
  <dcterms:created xsi:type="dcterms:W3CDTF">2018-06-19T14:49:33Z</dcterms:created>
  <dcterms:modified xsi:type="dcterms:W3CDTF">2019-10-08T02:57:36Z</dcterms:modified>
</cp:coreProperties>
</file>